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wmf" ContentType="image/x-wmf"/>
  <Override PartName="/ppt/media/image3.jpeg" ContentType="image/jpeg"/>
  <Override PartName="/ppt/media/image5.jpeg" ContentType="image/jpeg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1339D85D-BE98-467C-834E-304BFB36EEF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herbrooke samples #4, quantitations (Dec 13 1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2793B673-9F05-4176-A526-0B906BC00DF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550800"/>
                <a:tab algn="l" pos="1101600"/>
                <a:tab algn="l" pos="1652760"/>
                <a:tab algn="l" pos="2203560"/>
                <a:tab algn="l" pos="2754360"/>
                <a:tab algn="l" pos="3305160"/>
                <a:tab algn="l" pos="3855960"/>
                <a:tab algn="l" pos="4406760"/>
                <a:tab algn="l" pos="4957920"/>
                <a:tab algn="l" pos="5508720"/>
                <a:tab algn="l" pos="6059520"/>
                <a:tab algn="l" pos="6610320"/>
                <a:tab algn="l" pos="7161120"/>
                <a:tab algn="l" pos="7711920"/>
                <a:tab algn="l" pos="8263080"/>
                <a:tab algn="l" pos="8813880"/>
                <a:tab algn="l" pos="9364680"/>
                <a:tab algn="l" pos="9915480"/>
                <a:tab algn="l" pos="104662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herbrooke samples #4, quantitations (Dec 13 1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4C50F8CA-EEB2-49D5-8E0C-C31AF3E8438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E8F1E-99D1-4D05-AFC3-9610B4E223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6E2C3-51FB-4788-ABD7-62795DCFEA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3C541-9B74-4F6B-A64F-04B1A3769F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880"/>
            <a:ext cx="1987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57045-8CA3-4B06-96DE-AA0F7EAF20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B2700-0D55-446E-AAAE-1DB9A8FAC2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09186-0F58-48D1-B4CB-AE5DC753B2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9364E-EFCF-4AA0-8702-31E476B37C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EABBE-E167-40DA-8AA4-0F21FEBAFB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C6FE1-B621-4EB0-8FF8-B2D04D0F96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6CF3D-F172-44F8-8745-3D3F59F846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88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5BA77-9E60-4FC8-A8FD-B5B80592EF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6172200" cy="287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EF3E7-AFC8-4BC5-B69F-1E22F05447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4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2" marL="1139760" indent="-22680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1440" y="8475480"/>
            <a:ext cx="217512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fld id="{ECE57849-AB45-48DE-88AC-3A871EB1D57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wmf"/><Relationship Id="rId3" Type="http://schemas.openxmlformats.org/officeDocument/2006/relationships/image" Target="../media/image3.jpeg"/><Relationship Id="rId4" Type="http://schemas.openxmlformats.org/officeDocument/2006/relationships/image" Target="../media/image4.wmf"/><Relationship Id="rId5" Type="http://schemas.openxmlformats.org/officeDocument/2006/relationships/image" Target="../media/image5.jpeg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76"/>
          <p:cNvGrpSpPr/>
          <p:nvPr/>
        </p:nvGrpSpPr>
        <p:grpSpPr>
          <a:xfrm>
            <a:off x="1719000" y="3135240"/>
            <a:ext cx="3418920" cy="2184480"/>
            <a:chOff x="1719000" y="3135240"/>
            <a:chExt cx="3418920" cy="2184480"/>
          </a:xfrm>
        </p:grpSpPr>
        <p:grpSp>
          <p:nvGrpSpPr>
            <p:cNvPr id="49" name="Group 30"/>
            <p:cNvGrpSpPr/>
            <p:nvPr/>
          </p:nvGrpSpPr>
          <p:grpSpPr>
            <a:xfrm>
              <a:off x="3878640" y="3708360"/>
              <a:ext cx="199800" cy="1457280"/>
              <a:chOff x="3878640" y="3708360"/>
              <a:chExt cx="199800" cy="1457280"/>
            </a:xfrm>
          </p:grpSpPr>
          <p:sp>
            <p:nvSpPr>
              <p:cNvPr id="50" name="Rectangle 71"/>
              <p:cNvSpPr/>
              <p:nvPr/>
            </p:nvSpPr>
            <p:spPr>
              <a:xfrm>
                <a:off x="3878640" y="3708360"/>
                <a:ext cx="199800" cy="15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0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Rectangle 72"/>
              <p:cNvSpPr/>
              <p:nvPr/>
            </p:nvSpPr>
            <p:spPr>
              <a:xfrm>
                <a:off x="3878640" y="3816000"/>
                <a:ext cx="199800" cy="15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Rectangle 73"/>
              <p:cNvSpPr/>
              <p:nvPr/>
            </p:nvSpPr>
            <p:spPr>
              <a:xfrm>
                <a:off x="3878640" y="3972960"/>
                <a:ext cx="199800" cy="15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Rectangle 74"/>
              <p:cNvSpPr/>
              <p:nvPr/>
            </p:nvSpPr>
            <p:spPr>
              <a:xfrm>
                <a:off x="3878640" y="4128480"/>
                <a:ext cx="199800" cy="15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5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Rectangle 75"/>
              <p:cNvSpPr/>
              <p:nvPr/>
            </p:nvSpPr>
            <p:spPr>
              <a:xfrm>
                <a:off x="3878640" y="4452120"/>
                <a:ext cx="199800" cy="155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Rectangle 76"/>
              <p:cNvSpPr/>
              <p:nvPr/>
            </p:nvSpPr>
            <p:spPr>
              <a:xfrm>
                <a:off x="3878640" y="4686840"/>
                <a:ext cx="199800" cy="15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7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Rectangle 76"/>
              <p:cNvSpPr/>
              <p:nvPr/>
            </p:nvSpPr>
            <p:spPr>
              <a:xfrm>
                <a:off x="3878640" y="5008320"/>
                <a:ext cx="199800" cy="15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−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−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7" name="Group 27"/>
            <p:cNvGrpSpPr/>
            <p:nvPr/>
          </p:nvGrpSpPr>
          <p:grpSpPr>
            <a:xfrm>
              <a:off x="2217240" y="3135240"/>
              <a:ext cx="1086480" cy="2184480"/>
              <a:chOff x="2217240" y="3135240"/>
              <a:chExt cx="1086480" cy="2184480"/>
            </a:xfrm>
          </p:grpSpPr>
          <p:grpSp>
            <p:nvGrpSpPr>
              <p:cNvPr id="58" name="Group 19"/>
              <p:cNvGrpSpPr/>
              <p:nvPr/>
            </p:nvGrpSpPr>
            <p:grpSpPr>
              <a:xfrm>
                <a:off x="2304720" y="3729240"/>
                <a:ext cx="720360" cy="1590480"/>
                <a:chOff x="2304720" y="3729240"/>
                <a:chExt cx="720360" cy="1590480"/>
              </a:xfrm>
            </p:grpSpPr>
            <p:pic>
              <p:nvPicPr>
                <p:cNvPr id="59" name="Picture 36" descr=""/>
                <p:cNvPicPr/>
                <p:nvPr/>
              </p:nvPicPr>
              <p:blipFill>
                <a:blip r:embed="rId1"/>
                <a:srcRect l="23396" t="1765" r="16003" b="16807"/>
                <a:stretch/>
              </p:blipFill>
              <p:spPr>
                <a:xfrm>
                  <a:off x="2474640" y="3729240"/>
                  <a:ext cx="550440" cy="1590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0" name="Picture 10" descr=""/>
                <p:cNvPicPr/>
                <p:nvPr/>
              </p:nvPicPr>
              <p:blipFill>
                <a:blip r:embed="rId2"/>
                <a:srcRect l="31092" t="1372" r="23004" b="20838"/>
                <a:stretch/>
              </p:blipFill>
              <p:spPr>
                <a:xfrm>
                  <a:off x="2304720" y="3729240"/>
                  <a:ext cx="174960" cy="15904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61" name="Group 66"/>
              <p:cNvGrpSpPr/>
              <p:nvPr/>
            </p:nvGrpSpPr>
            <p:grpSpPr>
              <a:xfrm>
                <a:off x="2217240" y="3251880"/>
                <a:ext cx="1086480" cy="537840"/>
                <a:chOff x="2217240" y="3251880"/>
                <a:chExt cx="1086480" cy="537840"/>
              </a:xfrm>
            </p:grpSpPr>
            <p:sp>
              <p:nvSpPr>
                <p:cNvPr id="62" name="TextBox 72"/>
                <p:cNvSpPr/>
                <p:nvPr/>
              </p:nvSpPr>
              <p:spPr>
                <a:xfrm rot="18985800">
                  <a:off x="2225880" y="343764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yPr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TextBox 72"/>
                <p:cNvSpPr/>
                <p:nvPr/>
              </p:nvSpPr>
              <p:spPr>
                <a:xfrm rot="18985800">
                  <a:off x="2407320" y="343944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Vector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TextBox 72"/>
                <p:cNvSpPr/>
                <p:nvPr/>
              </p:nvSpPr>
              <p:spPr>
                <a:xfrm rot="18985800">
                  <a:off x="2574000" y="3416040"/>
                  <a:ext cx="543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sto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TextBox 72"/>
                <p:cNvSpPr/>
                <p:nvPr/>
              </p:nvSpPr>
              <p:spPr>
                <a:xfrm rot="18985800">
                  <a:off x="2752920" y="3412440"/>
                  <a:ext cx="552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-23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Straight Connector 144"/>
                <p:cNvSpPr/>
                <p:nvPr/>
              </p:nvSpPr>
              <p:spPr>
                <a:xfrm>
                  <a:off x="231444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Straight Connector 145"/>
                <p:cNvSpPr/>
                <p:nvPr/>
              </p:nvSpPr>
              <p:spPr>
                <a:xfrm>
                  <a:off x="249732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Straight Connector 146"/>
                <p:cNvSpPr/>
                <p:nvPr/>
              </p:nvSpPr>
              <p:spPr>
                <a:xfrm>
                  <a:off x="267984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Straight Connector 147"/>
                <p:cNvSpPr/>
                <p:nvPr/>
              </p:nvSpPr>
              <p:spPr>
                <a:xfrm>
                  <a:off x="285768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0" name="Straight Connector 138"/>
              <p:cNvSpPr/>
              <p:nvPr/>
            </p:nvSpPr>
            <p:spPr>
              <a:xfrm>
                <a:off x="2319120" y="3350880"/>
                <a:ext cx="68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TextBox 72"/>
              <p:cNvSpPr/>
              <p:nvPr/>
            </p:nvSpPr>
            <p:spPr>
              <a:xfrm>
                <a:off x="2400840" y="3135240"/>
                <a:ext cx="513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-Pr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2" name="Group 26"/>
            <p:cNvGrpSpPr/>
            <p:nvPr/>
          </p:nvGrpSpPr>
          <p:grpSpPr>
            <a:xfrm>
              <a:off x="3028320" y="3135240"/>
              <a:ext cx="1086480" cy="2184480"/>
              <a:chOff x="3028320" y="3135240"/>
              <a:chExt cx="1086480" cy="2184480"/>
            </a:xfrm>
          </p:grpSpPr>
          <p:grpSp>
            <p:nvGrpSpPr>
              <p:cNvPr id="73" name="Group 18"/>
              <p:cNvGrpSpPr/>
              <p:nvPr/>
            </p:nvGrpSpPr>
            <p:grpSpPr>
              <a:xfrm>
                <a:off x="3099240" y="3729240"/>
                <a:ext cx="720360" cy="1590480"/>
                <a:chOff x="3099240" y="3729240"/>
                <a:chExt cx="720360" cy="1590480"/>
              </a:xfrm>
            </p:grpSpPr>
            <p:pic>
              <p:nvPicPr>
                <p:cNvPr id="74" name="Picture 31" descr=""/>
                <p:cNvPicPr/>
                <p:nvPr/>
              </p:nvPicPr>
              <p:blipFill>
                <a:blip r:embed="rId3"/>
                <a:srcRect l="8341" t="1910" r="70670" b="15001"/>
                <a:stretch/>
              </p:blipFill>
              <p:spPr>
                <a:xfrm>
                  <a:off x="3267720" y="3729240"/>
                  <a:ext cx="551880" cy="1590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5" name="Picture 6" descr=""/>
                <p:cNvPicPr/>
                <p:nvPr/>
              </p:nvPicPr>
              <p:blipFill>
                <a:blip r:embed="rId4"/>
                <a:srcRect l="14188" t="3373" r="31101" b="18033"/>
                <a:stretch/>
              </p:blipFill>
              <p:spPr>
                <a:xfrm>
                  <a:off x="3099240" y="3729240"/>
                  <a:ext cx="177120" cy="15904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76" name="TextBox 72"/>
              <p:cNvSpPr/>
              <p:nvPr/>
            </p:nvSpPr>
            <p:spPr>
              <a:xfrm>
                <a:off x="3184200" y="3135240"/>
                <a:ext cx="56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-GFP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Straight Connector 124"/>
              <p:cNvSpPr/>
              <p:nvPr/>
            </p:nvSpPr>
            <p:spPr>
              <a:xfrm>
                <a:off x="3125880" y="3350880"/>
                <a:ext cx="68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78" name="Group 82"/>
              <p:cNvGrpSpPr/>
              <p:nvPr/>
            </p:nvGrpSpPr>
            <p:grpSpPr>
              <a:xfrm>
                <a:off x="3028320" y="3251880"/>
                <a:ext cx="1086480" cy="537840"/>
                <a:chOff x="3028320" y="3251880"/>
                <a:chExt cx="1086480" cy="537840"/>
              </a:xfrm>
            </p:grpSpPr>
            <p:sp>
              <p:nvSpPr>
                <p:cNvPr id="79" name="TextBox 72"/>
                <p:cNvSpPr/>
                <p:nvPr/>
              </p:nvSpPr>
              <p:spPr>
                <a:xfrm rot="18985800">
                  <a:off x="3036960" y="343656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yPr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TextBox 72"/>
                <p:cNvSpPr/>
                <p:nvPr/>
              </p:nvSpPr>
              <p:spPr>
                <a:xfrm rot="18985800">
                  <a:off x="3214440" y="343944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Vector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TextBox 72"/>
                <p:cNvSpPr/>
                <p:nvPr/>
              </p:nvSpPr>
              <p:spPr>
                <a:xfrm rot="18985800">
                  <a:off x="3385080" y="3416040"/>
                  <a:ext cx="543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sto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" name="TextBox 72"/>
                <p:cNvSpPr/>
                <p:nvPr/>
              </p:nvSpPr>
              <p:spPr>
                <a:xfrm rot="18985800">
                  <a:off x="3564000" y="3412440"/>
                  <a:ext cx="552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-23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" name="Straight Connector 130"/>
                <p:cNvSpPr/>
                <p:nvPr/>
              </p:nvSpPr>
              <p:spPr>
                <a:xfrm>
                  <a:off x="312588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" name="Straight Connector 131"/>
                <p:cNvSpPr/>
                <p:nvPr/>
              </p:nvSpPr>
              <p:spPr>
                <a:xfrm>
                  <a:off x="330840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Straight Connector 132"/>
                <p:cNvSpPr/>
                <p:nvPr/>
              </p:nvSpPr>
              <p:spPr>
                <a:xfrm>
                  <a:off x="349128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Straight Connector 133"/>
                <p:cNvSpPr/>
                <p:nvPr/>
              </p:nvSpPr>
              <p:spPr>
                <a:xfrm>
                  <a:off x="3669120" y="368892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87" name="Group 29"/>
            <p:cNvGrpSpPr/>
            <p:nvPr/>
          </p:nvGrpSpPr>
          <p:grpSpPr>
            <a:xfrm>
              <a:off x="4051440" y="3135240"/>
              <a:ext cx="1086480" cy="2184480"/>
              <a:chOff x="4051440" y="3135240"/>
              <a:chExt cx="1086480" cy="2184480"/>
            </a:xfrm>
          </p:grpSpPr>
          <p:grpSp>
            <p:nvGrpSpPr>
              <p:cNvPr id="88" name="Group 17"/>
              <p:cNvGrpSpPr/>
              <p:nvPr/>
            </p:nvGrpSpPr>
            <p:grpSpPr>
              <a:xfrm>
                <a:off x="4124520" y="3729600"/>
                <a:ext cx="720360" cy="1590120"/>
                <a:chOff x="4124520" y="3729600"/>
                <a:chExt cx="720360" cy="1590120"/>
              </a:xfrm>
            </p:grpSpPr>
            <p:pic>
              <p:nvPicPr>
                <p:cNvPr id="89" name="Picture 14" descr=""/>
                <p:cNvPicPr/>
                <p:nvPr/>
              </p:nvPicPr>
              <p:blipFill>
                <a:blip r:embed="rId5"/>
                <a:srcRect l="0" t="1679" r="11073" b="17064"/>
                <a:stretch/>
              </p:blipFill>
              <p:spPr>
                <a:xfrm>
                  <a:off x="4224600" y="3729600"/>
                  <a:ext cx="620280" cy="1590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0" name="Picture 16" descr=""/>
                <p:cNvPicPr/>
                <p:nvPr/>
              </p:nvPicPr>
              <p:blipFill>
                <a:blip r:embed="rId6"/>
                <a:srcRect l="32740" t="4378" r="37799" b="10530"/>
                <a:stretch/>
              </p:blipFill>
              <p:spPr>
                <a:xfrm>
                  <a:off x="4124520" y="3729600"/>
                  <a:ext cx="187200" cy="15901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91" name="Straight Connector 109"/>
              <p:cNvSpPr/>
              <p:nvPr/>
            </p:nvSpPr>
            <p:spPr>
              <a:xfrm>
                <a:off x="4145040" y="3350880"/>
                <a:ext cx="68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Box 72"/>
              <p:cNvSpPr/>
              <p:nvPr/>
            </p:nvSpPr>
            <p:spPr>
              <a:xfrm>
                <a:off x="4083120" y="3135240"/>
                <a:ext cx="81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5760"/>
                    <a:tab algn="l" pos="911160"/>
                    <a:tab algn="l" pos="1366920"/>
                    <a:tab algn="l" pos="1822320"/>
                    <a:tab algn="l" pos="2278080"/>
                    <a:tab algn="l" pos="2733840"/>
                    <a:tab algn="l" pos="3189240"/>
                    <a:tab algn="l" pos="3645000"/>
                    <a:tab algn="l" pos="4100400"/>
                    <a:tab algn="l" pos="4556160"/>
                    <a:tab algn="l" pos="5011560"/>
                    <a:tab algn="l" pos="5467320"/>
                    <a:tab algn="l" pos="5923080"/>
                    <a:tab algn="l" pos="6378480"/>
                    <a:tab algn="l" pos="6834240"/>
                    <a:tab algn="l" pos="7289640"/>
                    <a:tab algn="l" pos="7745400"/>
                    <a:tab algn="l" pos="8201160"/>
                    <a:tab algn="l" pos="8656560"/>
                    <a:tab algn="l" pos="911232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omassi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3" name="Group 91"/>
              <p:cNvGrpSpPr/>
              <p:nvPr/>
            </p:nvGrpSpPr>
            <p:grpSpPr>
              <a:xfrm>
                <a:off x="4051440" y="3252240"/>
                <a:ext cx="1086480" cy="537480"/>
                <a:chOff x="4051440" y="3252240"/>
                <a:chExt cx="1086480" cy="537480"/>
              </a:xfrm>
            </p:grpSpPr>
            <p:sp>
              <p:nvSpPr>
                <p:cNvPr id="94" name="TextBox 72"/>
                <p:cNvSpPr/>
                <p:nvPr/>
              </p:nvSpPr>
              <p:spPr>
                <a:xfrm rot="18985800">
                  <a:off x="4060080" y="343692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yPr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" name="TextBox 72"/>
                <p:cNvSpPr/>
                <p:nvPr/>
              </p:nvSpPr>
              <p:spPr>
                <a:xfrm rot="18985800">
                  <a:off x="4237560" y="3435480"/>
                  <a:ext cx="476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Vector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" name="TextBox 72"/>
                <p:cNvSpPr/>
                <p:nvPr/>
              </p:nvSpPr>
              <p:spPr>
                <a:xfrm rot="18985800">
                  <a:off x="4408200" y="3416400"/>
                  <a:ext cx="543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stop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7" name="TextBox 72"/>
                <p:cNvSpPr/>
                <p:nvPr/>
              </p:nvSpPr>
              <p:spPr>
                <a:xfrm rot="18985800">
                  <a:off x="4587120" y="3412800"/>
                  <a:ext cx="5526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5760"/>
                      <a:tab algn="l" pos="911160"/>
                      <a:tab algn="l" pos="1366920"/>
                      <a:tab algn="l" pos="1822320"/>
                      <a:tab algn="l" pos="2278080"/>
                      <a:tab algn="l" pos="2733840"/>
                      <a:tab algn="l" pos="3189240"/>
                      <a:tab algn="l" pos="3645000"/>
                      <a:tab algn="l" pos="4100400"/>
                      <a:tab algn="l" pos="4556160"/>
                      <a:tab algn="l" pos="5011560"/>
                      <a:tab algn="l" pos="5467320"/>
                      <a:tab algn="l" pos="5923080"/>
                      <a:tab algn="l" pos="6378480"/>
                      <a:tab algn="l" pos="6834240"/>
                      <a:tab algn="l" pos="7289640"/>
                      <a:tab algn="l" pos="7745400"/>
                      <a:tab algn="l" pos="8201160"/>
                      <a:tab algn="l" pos="8656560"/>
                      <a:tab algn="l" pos="911232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4-23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Straight Connector 116"/>
                <p:cNvSpPr/>
                <p:nvPr/>
              </p:nvSpPr>
              <p:spPr>
                <a:xfrm>
                  <a:off x="4149720" y="36892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Straight Connector 117"/>
                <p:cNvSpPr/>
                <p:nvPr/>
              </p:nvSpPr>
              <p:spPr>
                <a:xfrm>
                  <a:off x="4332240" y="36892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Straight Connector 118"/>
                <p:cNvSpPr/>
                <p:nvPr/>
              </p:nvSpPr>
              <p:spPr>
                <a:xfrm>
                  <a:off x="4515120" y="36892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Straight Connector 119"/>
                <p:cNvSpPr/>
                <p:nvPr/>
              </p:nvSpPr>
              <p:spPr>
                <a:xfrm>
                  <a:off x="4692960" y="3689280"/>
                  <a:ext cx="144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102" name="Isosceles Triangle 83"/>
            <p:cNvSpPr/>
            <p:nvPr/>
          </p:nvSpPr>
          <p:spPr>
            <a:xfrm flipH="1" rot="5400000">
              <a:off x="2221560" y="4536720"/>
              <a:ext cx="48960" cy="745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Isosceles Triangle 84"/>
            <p:cNvSpPr/>
            <p:nvPr/>
          </p:nvSpPr>
          <p:spPr>
            <a:xfrm flipH="1" rot="5400000">
              <a:off x="2224080" y="4743720"/>
              <a:ext cx="47520" cy="72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pPr algn="ctr"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Isosceles Triangle 85"/>
            <p:cNvSpPr/>
            <p:nvPr/>
          </p:nvSpPr>
          <p:spPr>
            <a:xfrm flipH="1" rot="5400000">
              <a:off x="2224080" y="4832640"/>
              <a:ext cx="47520" cy="72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ctr">
              <a:noAutofit/>
            </a:bodyPr>
            <a:p>
              <a:pPr algn="ctr"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39"/>
            <p:cNvSpPr/>
            <p:nvPr/>
          </p:nvSpPr>
          <p:spPr>
            <a:xfrm>
              <a:off x="1725480" y="4663080"/>
              <a:ext cx="54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4sto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118"/>
            <p:cNvSpPr/>
            <p:nvPr/>
          </p:nvSpPr>
          <p:spPr>
            <a:xfrm>
              <a:off x="1797480" y="44643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Pr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119"/>
            <p:cNvSpPr/>
            <p:nvPr/>
          </p:nvSpPr>
          <p:spPr>
            <a:xfrm>
              <a:off x="1719000" y="4761360"/>
              <a:ext cx="55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4-2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Straight Connector 93"/>
            <p:cNvSpPr/>
            <p:nvPr/>
          </p:nvSpPr>
          <p:spPr>
            <a:xfrm>
              <a:off x="2478240" y="3751200"/>
              <a:ext cx="0" cy="1548000"/>
            </a:xfrm>
            <a:prstGeom prst="line">
              <a:avLst/>
            </a:prstGeom>
            <a:ln w="12600">
              <a:solidFill>
                <a:srgbClr val="7f7f7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Straight Connector 94"/>
            <p:cNvSpPr/>
            <p:nvPr/>
          </p:nvSpPr>
          <p:spPr>
            <a:xfrm>
              <a:off x="3283200" y="3751200"/>
              <a:ext cx="0" cy="1548000"/>
            </a:xfrm>
            <a:prstGeom prst="line">
              <a:avLst/>
            </a:prstGeom>
            <a:ln w="12600">
              <a:solidFill>
                <a:srgbClr val="7f7f7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Straight Connector 95"/>
            <p:cNvSpPr/>
            <p:nvPr/>
          </p:nvSpPr>
          <p:spPr>
            <a:xfrm>
              <a:off x="4313520" y="3751200"/>
              <a:ext cx="0" cy="1548000"/>
            </a:xfrm>
            <a:prstGeom prst="line">
              <a:avLst/>
            </a:prstGeom>
            <a:ln w="12600">
              <a:solidFill>
                <a:srgbClr val="7f7f7f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76"/>
            <p:cNvSpPr/>
            <p:nvPr/>
          </p:nvSpPr>
          <p:spPr>
            <a:xfrm>
              <a:off x="2775240" y="4659480"/>
              <a:ext cx="199800" cy="1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76"/>
            <p:cNvSpPr/>
            <p:nvPr/>
          </p:nvSpPr>
          <p:spPr>
            <a:xfrm>
              <a:off x="3736440" y="4746960"/>
              <a:ext cx="199800" cy="1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76"/>
            <p:cNvSpPr/>
            <p:nvPr/>
          </p:nvSpPr>
          <p:spPr>
            <a:xfrm>
              <a:off x="2424240" y="4449960"/>
              <a:ext cx="199800" cy="1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76"/>
            <p:cNvSpPr/>
            <p:nvPr/>
          </p:nvSpPr>
          <p:spPr>
            <a:xfrm>
              <a:off x="3556800" y="4650120"/>
              <a:ext cx="199800" cy="1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76"/>
            <p:cNvSpPr/>
            <p:nvPr/>
          </p:nvSpPr>
          <p:spPr>
            <a:xfrm>
              <a:off x="3229560" y="4442040"/>
              <a:ext cx="199800" cy="15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69" descr="1 - Histogram of Data 2.pdf"/>
          <p:cNvPicPr/>
          <p:nvPr/>
        </p:nvPicPr>
        <p:blipFill>
          <a:blip r:embed="rId1"/>
          <a:srcRect l="17702" t="31003" r="6284" b="18465"/>
          <a:stretch/>
        </p:blipFill>
        <p:spPr>
          <a:xfrm>
            <a:off x="1870200" y="3760920"/>
            <a:ext cx="3260520" cy="1622160"/>
          </a:xfrm>
          <a:prstGeom prst="rect">
            <a:avLst/>
          </a:prstGeom>
          <a:ln w="0">
            <a:noFill/>
          </a:ln>
        </p:spPr>
      </p:pic>
      <p:sp>
        <p:nvSpPr>
          <p:cNvPr id="117" name="TextBox 1"/>
          <p:cNvSpPr/>
          <p:nvPr/>
        </p:nvSpPr>
        <p:spPr>
          <a:xfrm>
            <a:off x="1916280" y="532620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00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71"/>
          <p:cNvSpPr/>
          <p:nvPr/>
        </p:nvSpPr>
        <p:spPr>
          <a:xfrm>
            <a:off x="2264040" y="532620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72"/>
          <p:cNvSpPr/>
          <p:nvPr/>
        </p:nvSpPr>
        <p:spPr>
          <a:xfrm>
            <a:off x="2595240" y="5326200"/>
            <a:ext cx="435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2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73"/>
          <p:cNvSpPr/>
          <p:nvPr/>
        </p:nvSpPr>
        <p:spPr>
          <a:xfrm>
            <a:off x="292644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2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6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74"/>
          <p:cNvSpPr/>
          <p:nvPr/>
        </p:nvSpPr>
        <p:spPr>
          <a:xfrm>
            <a:off x="327564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6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0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75"/>
          <p:cNvSpPr/>
          <p:nvPr/>
        </p:nvSpPr>
        <p:spPr>
          <a:xfrm>
            <a:off x="362304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0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4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76"/>
          <p:cNvSpPr/>
          <p:nvPr/>
        </p:nvSpPr>
        <p:spPr>
          <a:xfrm>
            <a:off x="396540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4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8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77"/>
          <p:cNvSpPr/>
          <p:nvPr/>
        </p:nvSpPr>
        <p:spPr>
          <a:xfrm>
            <a:off x="431208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8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2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78"/>
          <p:cNvSpPr/>
          <p:nvPr/>
        </p:nvSpPr>
        <p:spPr>
          <a:xfrm>
            <a:off x="4667760" y="5326200"/>
            <a:ext cx="46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2.01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6.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79"/>
          <p:cNvSpPr/>
          <p:nvPr/>
        </p:nvSpPr>
        <p:spPr>
          <a:xfrm>
            <a:off x="1727640" y="51944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80"/>
          <p:cNvSpPr/>
          <p:nvPr/>
        </p:nvSpPr>
        <p:spPr>
          <a:xfrm>
            <a:off x="1671120" y="4759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81"/>
          <p:cNvSpPr/>
          <p:nvPr/>
        </p:nvSpPr>
        <p:spPr>
          <a:xfrm>
            <a:off x="1671120" y="4330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82"/>
          <p:cNvSpPr/>
          <p:nvPr/>
        </p:nvSpPr>
        <p:spPr>
          <a:xfrm>
            <a:off x="1671120" y="4165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86"/>
          <p:cNvSpPr/>
          <p:nvPr/>
        </p:nvSpPr>
        <p:spPr>
          <a:xfrm>
            <a:off x="1671120" y="4033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87"/>
          <p:cNvSpPr/>
          <p:nvPr/>
        </p:nvSpPr>
        <p:spPr>
          <a:xfrm>
            <a:off x="1671120" y="3913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88"/>
          <p:cNvSpPr/>
          <p:nvPr/>
        </p:nvSpPr>
        <p:spPr>
          <a:xfrm>
            <a:off x="1614240" y="37926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89"/>
          <p:cNvSpPr/>
          <p:nvPr/>
        </p:nvSpPr>
        <p:spPr>
          <a:xfrm rot="16200000">
            <a:off x="1045080" y="4483080"/>
            <a:ext cx="96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requency, 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90"/>
          <p:cNvSpPr/>
          <p:nvPr/>
        </p:nvSpPr>
        <p:spPr>
          <a:xfrm>
            <a:off x="3110760" y="567864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5760"/>
                <a:tab algn="l" pos="911160"/>
                <a:tab algn="l" pos="1366920"/>
                <a:tab algn="l" pos="1822320"/>
                <a:tab algn="l" pos="2278080"/>
                <a:tab algn="l" pos="2733840"/>
                <a:tab algn="l" pos="3189240"/>
                <a:tab algn="l" pos="3645000"/>
                <a:tab algn="l" pos="4100400"/>
                <a:tab algn="l" pos="4556160"/>
                <a:tab algn="l" pos="5011560"/>
                <a:tab algn="l" pos="5467320"/>
                <a:tab algn="l" pos="5923080"/>
                <a:tab algn="l" pos="6378480"/>
                <a:tab algn="l" pos="6834240"/>
                <a:tab algn="l" pos="7289640"/>
                <a:tab algn="l" pos="7745400"/>
                <a:tab algn="l" pos="8201160"/>
                <a:tab algn="l" pos="8656560"/>
                <a:tab algn="l" pos="91123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aw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5" name="Group 3"/>
          <p:cNvGrpSpPr/>
          <p:nvPr/>
        </p:nvGrpSpPr>
        <p:grpSpPr>
          <a:xfrm>
            <a:off x="3956040" y="3724200"/>
            <a:ext cx="1125000" cy="533520"/>
            <a:chOff x="3956040" y="3724200"/>
            <a:chExt cx="1125000" cy="533520"/>
          </a:xfrm>
        </p:grpSpPr>
        <p:pic>
          <p:nvPicPr>
            <p:cNvPr id="136" name="Picture 91" descr="1 - Histogram of Data 2.pdf"/>
            <p:cNvPicPr/>
            <p:nvPr/>
          </p:nvPicPr>
          <p:blipFill>
            <a:blip r:embed="rId2"/>
            <a:srcRect l="76152" t="0" r="12975" b="80022"/>
            <a:stretch/>
          </p:blipFill>
          <p:spPr>
            <a:xfrm>
              <a:off x="3956040" y="3724200"/>
              <a:ext cx="327960" cy="53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7" name="TextBox 92"/>
            <p:cNvSpPr/>
            <p:nvPr/>
          </p:nvSpPr>
          <p:spPr>
            <a:xfrm>
              <a:off x="4204440" y="3795120"/>
              <a:ext cx="777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2a lysat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96"/>
            <p:cNvSpPr/>
            <p:nvPr/>
          </p:nvSpPr>
          <p:spPr>
            <a:xfrm>
              <a:off x="4205520" y="3979080"/>
              <a:ext cx="87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5760"/>
                  <a:tab algn="l" pos="911160"/>
                  <a:tab algn="l" pos="1366920"/>
                  <a:tab algn="l" pos="1822320"/>
                  <a:tab algn="l" pos="2278080"/>
                  <a:tab algn="l" pos="2733840"/>
                  <a:tab algn="l" pos="3189240"/>
                  <a:tab algn="l" pos="3645000"/>
                  <a:tab algn="l" pos="4100400"/>
                  <a:tab algn="l" pos="4556160"/>
                  <a:tab algn="l" pos="5011560"/>
                  <a:tab algn="l" pos="5467320"/>
                  <a:tab algn="l" pos="5923080"/>
                  <a:tab algn="l" pos="6378480"/>
                  <a:tab algn="l" pos="6834240"/>
                  <a:tab algn="l" pos="7289640"/>
                  <a:tab algn="l" pos="7745400"/>
                  <a:tab algn="l" pos="8201160"/>
                  <a:tab algn="l" pos="8656560"/>
                  <a:tab algn="l" pos="91123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use bra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6T17:26:42Z</dcterms:created>
  <dc:creator>Rory Shott</dc:creator>
  <dc:description/>
  <dc:language>en-US</dc:language>
  <cp:lastModifiedBy>Rory Shott</cp:lastModifiedBy>
  <cp:lastPrinted>2013-08-13T22:20:03Z</cp:lastPrinted>
  <dcterms:modified xsi:type="dcterms:W3CDTF">2014-04-15T22:19:01Z</dcterms:modified>
  <cp:revision>358</cp:revision>
  <dc:subject/>
  <dc:title>PowerPoint Presentation</dc:title>
</cp:coreProperties>
</file>